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96" r:id="rId2"/>
  </p:sldIdLst>
  <p:sldSz cx="15562263" cy="17546638"/>
  <p:notesSz cx="6858000" cy="9144000"/>
  <p:defaultTextStyle>
    <a:defPPr>
      <a:defRPr lang="en-US"/>
    </a:defPPr>
    <a:lvl1pPr marL="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0000"/>
    <a:srgbClr val="FFFFFF"/>
    <a:srgbClr val="FF40FF"/>
    <a:srgbClr val="AC27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2A8C4E5-A43A-CC46-B02B-7F3275880045}" v="10" dt="2024-08-15T19:02:14.80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19"/>
    <p:restoredTop sz="83739"/>
  </p:normalViewPr>
  <p:slideViewPr>
    <p:cSldViewPr snapToGrid="0">
      <p:cViewPr varScale="1">
        <p:scale>
          <a:sx n="62" d="100"/>
          <a:sy n="62" d="100"/>
        </p:scale>
        <p:origin x="2136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B1137E9-3125-C9DC-069E-2EFC7FD4E75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E7326-5A68-8CF5-B93F-4FAFF79AC1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B62AE7-0510-7043-8514-23341998D747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3C3C2B-31C4-A7B8-7F9A-4B2F8EF1A33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1B5F93-70EB-5C72-5813-7DFAB1A2F89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5B7DB3-4B09-6441-9E1D-2E54A81E2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559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25ECA-95A8-D54D-A55C-966C5ABDC60E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0575" y="1143000"/>
            <a:ext cx="2736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02569-D9CA-7442-9875-62C29A14A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1143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202569-D9CA-7442-9875-62C29A14AB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6126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139EB-7257-7444-846C-A830F519A4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45286" y="2871639"/>
            <a:ext cx="11671697" cy="6108831"/>
          </a:xfrm>
        </p:spPr>
        <p:txBody>
          <a:bodyPr anchor="b">
            <a:normAutofit/>
          </a:bodyPr>
          <a:lstStyle>
            <a:lvl1pPr algn="ctr">
              <a:defRPr sz="4679"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FF011D-5936-024D-894E-5D7272C02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945286" y="9216051"/>
            <a:ext cx="11671697" cy="4236375"/>
          </a:xfrm>
        </p:spPr>
        <p:txBody>
          <a:bodyPr/>
          <a:lstStyle>
            <a:lvl1pPr marL="0" indent="0" algn="ctr">
              <a:buNone/>
              <a:defRPr sz="2808">
                <a:latin typeface="Helvetica" pitchFamily="2" charset="0"/>
                <a:cs typeface="Arial" panose="020B0604020202020204" pitchFamily="34" charset="0"/>
              </a:defRPr>
            </a:lvl1pPr>
            <a:lvl2pPr marL="534800" indent="0" algn="ctr">
              <a:buNone/>
              <a:defRPr sz="2339"/>
            </a:lvl2pPr>
            <a:lvl3pPr marL="1069601" indent="0" algn="ctr">
              <a:buNone/>
              <a:defRPr sz="2105"/>
            </a:lvl3pPr>
            <a:lvl4pPr marL="1604400" indent="0" algn="ctr">
              <a:buNone/>
              <a:defRPr sz="1871"/>
            </a:lvl4pPr>
            <a:lvl5pPr marL="2139200" indent="0" algn="ctr">
              <a:buNone/>
              <a:defRPr sz="1871"/>
            </a:lvl5pPr>
            <a:lvl6pPr marL="2674001" indent="0" algn="ctr">
              <a:buNone/>
              <a:defRPr sz="1871"/>
            </a:lvl6pPr>
            <a:lvl7pPr marL="3208801" indent="0" algn="ctr">
              <a:buNone/>
              <a:defRPr sz="1871"/>
            </a:lvl7pPr>
            <a:lvl8pPr marL="3743601" indent="0" algn="ctr">
              <a:buNone/>
              <a:defRPr sz="1871"/>
            </a:lvl8pPr>
            <a:lvl9pPr marL="4278401" indent="0" algn="ctr">
              <a:buNone/>
              <a:defRPr sz="187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64D72-5071-ED4A-AF12-75657B75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1C9DEA9D-5532-1949-9D14-26A30D988B6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047D9-31F9-BC40-AB2B-EC56AF8F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6870F0-923B-0543-854F-D39BA6762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17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7044D-B51F-4546-8184-768D6ADE8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F9904-7979-7F43-95DE-C5378709E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F89EC-86B5-C74C-AABB-DC262193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1DBA4-200E-9843-B255-CEC4C6AAC196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63029-53B8-844B-B239-06CD1560A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18CD-F8BD-C44A-8597-C2DB47E4D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21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8C94FF-AADF-BF41-A28C-B3390397EB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1136743" y="934196"/>
            <a:ext cx="3355614" cy="148699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FF3FEE-5F40-F248-B556-E00AA42CA1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69908" y="934196"/>
            <a:ext cx="9872310" cy="148699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DF995-7FA5-864D-AF3F-7D6AB7AE2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AFD97-F89F-A042-BCAC-BC0C1F5BBEE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0E0DB7-A73C-F146-A650-8078BA459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75EA6-BF6F-744E-9873-479596026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23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6BCAB-63B0-0B40-A1CD-6F636AE3D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73C1FF-5975-A24B-9612-9F4D8078E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  <a:lvl2pPr>
              <a:defRPr>
                <a:latin typeface="Helvetica" pitchFamily="2" charset="0"/>
              </a:defRPr>
            </a:lvl2pPr>
            <a:lvl3pPr>
              <a:defRPr>
                <a:latin typeface="Helvetica" pitchFamily="2" charset="0"/>
              </a:defRPr>
            </a:lvl3pPr>
            <a:lvl4pPr>
              <a:defRPr>
                <a:latin typeface="Helvetica" pitchFamily="2" charset="0"/>
              </a:defRPr>
            </a:lvl4pPr>
            <a:lvl5pPr>
              <a:defRPr>
                <a:latin typeface="Helvetica" pitchFamily="2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7CDC7-9740-B040-983D-33DDDDE70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340408B7-D42E-4C40-89A4-53776FE370D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FD91A-E71C-1D47-94FA-105097732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963D9-D362-084E-A363-1035C73F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05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406A6-B130-8646-91CA-51BA70943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1801" y="4374479"/>
            <a:ext cx="13422452" cy="7298912"/>
          </a:xfrm>
        </p:spPr>
        <p:txBody>
          <a:bodyPr anchor="b"/>
          <a:lstStyle>
            <a:lvl1pPr>
              <a:defRPr sz="701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107092-8299-0F4C-96A4-1F50B49D6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1801" y="11742440"/>
            <a:ext cx="13422452" cy="3838326"/>
          </a:xfrm>
        </p:spPr>
        <p:txBody>
          <a:bodyPr/>
          <a:lstStyle>
            <a:lvl1pPr marL="0" indent="0">
              <a:buNone/>
              <a:defRPr sz="2808">
                <a:solidFill>
                  <a:schemeClr val="tx1">
                    <a:tint val="75000"/>
                  </a:schemeClr>
                </a:solidFill>
              </a:defRPr>
            </a:lvl1pPr>
            <a:lvl2pPr marL="534800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2pPr>
            <a:lvl3pPr marL="1069601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6044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92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40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88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36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84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234A5-3EA3-114F-9B8B-EB41ACD3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F1EB0-11AC-F446-8CA5-7341363638B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FDE48-88CC-6844-9818-67B67F5D1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2AAED-26E7-0944-8097-920E2AE2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8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E0AA4-ECB6-C649-A5FD-599CA1B4B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37DD4-21E9-A04D-8AAA-6FF372C4F1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69908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AE2B60-9163-5C47-B9BE-BB764836C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878397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A7DC1-0841-544D-8B31-7BAE4AD41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080E-0CB5-2941-B48B-86F18F07B5FA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660F6-B518-6B45-868E-407C95D4D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DDEB9-06EA-3740-BB27-3320884BE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189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F03E9-9489-B344-96BA-70C2254D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2" y="934198"/>
            <a:ext cx="13422452" cy="339153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D0287-7AFF-A84D-916C-B7822B3E6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71933" y="4301366"/>
            <a:ext cx="6583566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586489-A7CB-EE4F-8D4A-9A4C48846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71933" y="6409396"/>
            <a:ext cx="6583566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F99574-E31E-EF42-916F-6A9CC901AE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878398" y="4301366"/>
            <a:ext cx="6615989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353DB1-1C23-404C-9DE8-78219D7C78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878398" y="6409396"/>
            <a:ext cx="6615989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B1BB78-2A66-9D4F-BFBB-BB7E1C9A5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C91F-C901-C74E-B457-F7DD6456F136}" type="datetime1">
              <a:rPr lang="en-US" smtClean="0"/>
              <a:t>8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FFCAAF-9320-C347-9837-DA18EAECC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93220E-C952-9842-ADE8-3451593D1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2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BD052-973D-994F-AF52-2A4EF5FBD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FF58DD-8363-6A46-9A18-1A3A67A0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9D0AC-686B-8B49-B366-3C844C4036EB}" type="datetime1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8FEACB-F9AE-8C44-97F6-788024312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56A4EF-28C8-B843-B0C9-3D10255B9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9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3EE6B9-1BFB-B447-ADE2-74BAB0E6F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D6573-C21F-0840-BAEF-1FF2575D4505}" type="datetime1">
              <a:rPr lang="en-US" smtClean="0"/>
              <a:t>8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C450CF-5F7E-5045-8B0A-4C0434E6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094176-5BE4-AD43-A449-C8199EE33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9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C1379-D019-6643-B88B-FB65AC5F9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58BD4D-DDCA-534A-8E83-F635DBDD4E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>
              <a:defRPr sz="3743"/>
            </a:lvl1pPr>
            <a:lvl2pPr>
              <a:defRPr sz="3275"/>
            </a:lvl2pPr>
            <a:lvl3pPr>
              <a:defRPr sz="2808"/>
            </a:lvl3pPr>
            <a:lvl4pPr>
              <a:defRPr sz="2339"/>
            </a:lvl4pPr>
            <a:lvl5pPr>
              <a:defRPr sz="2339"/>
            </a:lvl5pPr>
            <a:lvl6pPr>
              <a:defRPr sz="2339"/>
            </a:lvl6pPr>
            <a:lvl7pPr>
              <a:defRPr sz="2339"/>
            </a:lvl7pPr>
            <a:lvl8pPr>
              <a:defRPr sz="2339"/>
            </a:lvl8pPr>
            <a:lvl9pPr>
              <a:defRPr sz="2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42C9D0-AF82-204E-8201-19343DD61D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368A2-7186-E749-BB60-CB45376A4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D7268-FD7C-C042-A400-6B8C34629FE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9BA04-E120-A946-B561-D46CCA017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C79DB-2B92-7742-9F5E-538E7EE6C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297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C82B-7C1B-8F43-8CBD-0D90B839A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15C3E0-9E53-C34D-8BE5-403FD64408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 marL="0" indent="0">
              <a:buNone/>
              <a:defRPr sz="3743"/>
            </a:lvl1pPr>
            <a:lvl2pPr marL="534800" indent="0">
              <a:buNone/>
              <a:defRPr sz="3275"/>
            </a:lvl2pPr>
            <a:lvl3pPr marL="1069601" indent="0">
              <a:buNone/>
              <a:defRPr sz="2808"/>
            </a:lvl3pPr>
            <a:lvl4pPr marL="1604400" indent="0">
              <a:buNone/>
              <a:defRPr sz="2339"/>
            </a:lvl4pPr>
            <a:lvl5pPr marL="2139200" indent="0">
              <a:buNone/>
              <a:defRPr sz="2339"/>
            </a:lvl5pPr>
            <a:lvl6pPr marL="2674001" indent="0">
              <a:buNone/>
              <a:defRPr sz="2339"/>
            </a:lvl6pPr>
            <a:lvl7pPr marL="3208801" indent="0">
              <a:buNone/>
              <a:defRPr sz="2339"/>
            </a:lvl7pPr>
            <a:lvl8pPr marL="3743601" indent="0">
              <a:buNone/>
              <a:defRPr sz="2339"/>
            </a:lvl8pPr>
            <a:lvl9pPr marL="4278401" indent="0">
              <a:buNone/>
              <a:defRPr sz="2339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4C6D1B-B939-084A-AA38-F2265164B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5EC78-0900-3A42-A704-5CF19E63C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9D5A2-F22A-5741-B25B-A3DF52EE188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E44BA-DA4D-FB45-BD8D-5126D010E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FA10B7-6203-F24D-9E0C-733A6B0C2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04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985200-F03E-DA4D-914D-EBD5272FA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9906" y="934198"/>
            <a:ext cx="13422452" cy="2809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27D6C5-F073-1E46-B343-DB812445F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9906" y="3743282"/>
            <a:ext cx="13422452" cy="1207208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EB330-0B14-4A48-890E-1E18399472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69908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232FD189-7F13-AC44-ADD0-90F8923151E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F21E18-00F1-0145-899C-ECF615AEA9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155000" y="16263137"/>
            <a:ext cx="5252264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FFE07-FCDD-3549-9A82-C340CF9F90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990849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72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1069601" rtl="0" eaLnBrk="1" latinLnBrk="0" hangingPunct="1">
        <a:lnSpc>
          <a:spcPct val="90000"/>
        </a:lnSpc>
        <a:spcBef>
          <a:spcPct val="0"/>
        </a:spcBef>
        <a:buNone/>
        <a:defRPr sz="3275" kern="1200">
          <a:solidFill>
            <a:schemeClr val="tx1"/>
          </a:solidFill>
          <a:latin typeface="Helvetica" pitchFamily="2" charset="0"/>
          <a:ea typeface="+mj-ea"/>
          <a:cs typeface="Arial" panose="020B0604020202020204" pitchFamily="34" charset="0"/>
        </a:defRPr>
      </a:lvl1pPr>
    </p:titleStyle>
    <p:bodyStyle>
      <a:lvl1pPr marL="267400" indent="-267400" algn="l" defTabSz="1069601" rtl="0" eaLnBrk="1" latinLnBrk="0" hangingPunct="1">
        <a:lnSpc>
          <a:spcPct val="90000"/>
        </a:lnSpc>
        <a:spcBef>
          <a:spcPts val="117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1pPr>
      <a:lvl2pPr marL="8022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2pPr>
      <a:lvl3pPr marL="13370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871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3pPr>
      <a:lvl4pPr marL="1871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4pPr>
      <a:lvl5pPr marL="24066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404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5pPr>
      <a:lvl6pPr marL="29414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4762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40110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545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348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2pPr>
      <a:lvl3pPr marL="1069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3pPr>
      <a:lvl4pPr marL="16044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1392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6740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2088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3743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2784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tiff"/><Relationship Id="rId26" Type="http://schemas.openxmlformats.org/officeDocument/2006/relationships/image" Target="../media/image24.tiff"/><Relationship Id="rId3" Type="http://schemas.openxmlformats.org/officeDocument/2006/relationships/image" Target="../media/image1.emf"/><Relationship Id="rId21" Type="http://schemas.openxmlformats.org/officeDocument/2006/relationships/image" Target="../media/image19.tif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tiff"/><Relationship Id="rId25" Type="http://schemas.openxmlformats.org/officeDocument/2006/relationships/image" Target="../media/image23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tiff"/><Relationship Id="rId5" Type="http://schemas.openxmlformats.org/officeDocument/2006/relationships/image" Target="../media/image3.emf"/><Relationship Id="rId15" Type="http://schemas.openxmlformats.org/officeDocument/2006/relationships/image" Target="../media/image13.tiff"/><Relationship Id="rId23" Type="http://schemas.openxmlformats.org/officeDocument/2006/relationships/image" Target="../media/image21.tiff"/><Relationship Id="rId10" Type="http://schemas.openxmlformats.org/officeDocument/2006/relationships/image" Target="../media/image8.emf"/><Relationship Id="rId19" Type="http://schemas.openxmlformats.org/officeDocument/2006/relationships/image" Target="../media/image17.tif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5F74B3-D458-EBB5-9A47-4958F4FE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pPr/>
              <a:t>1</a:t>
            </a:fld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259A06-E51D-F074-9C21-F0C88B678F0F}"/>
              </a:ext>
            </a:extLst>
          </p:cNvPr>
          <p:cNvSpPr txBox="1"/>
          <p:nvPr/>
        </p:nvSpPr>
        <p:spPr>
          <a:xfrm>
            <a:off x="458876" y="14854407"/>
            <a:ext cx="1431827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Flow cytometry analysis of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 derived TAMs.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vo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M marker analysis.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efly, mice were inoculated with CAOV4 cells and treated with either vehicle, carboplatin or carboplatin plus BLZ945. Mice were sacrificed at 3 days following 4 cycles of carboplatin or allowed to reach endpoint criteria. Tumors were disassociated and analyzed for TAM population expression (CD45+CD11b+F4/80+), M1-like (MHC-II+CD80+CD86+) and M2-like (CD163+CD206+CD273+) phenotypes. A) Representative gates of vehicle and carboplatin treatment in regrown tumors. B) Quantification of M1-like and M2-like phenotypes in residual and regrown tumors of vehicle and carboplatin treatment. Unpaired t-test. Mean and SD. *p&lt;0.05, no stars indicate ns. 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A99A7283-7E12-7980-FF58-81A511CD4231}"/>
              </a:ext>
            </a:extLst>
          </p:cNvPr>
          <p:cNvGrpSpPr/>
          <p:nvPr/>
        </p:nvGrpSpPr>
        <p:grpSpPr>
          <a:xfrm>
            <a:off x="7463232" y="8763101"/>
            <a:ext cx="7579978" cy="5746553"/>
            <a:chOff x="7463232" y="8763101"/>
            <a:chExt cx="7579978" cy="5746553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5937E3B7-C0D7-C9F0-61A6-1D1C7AE25C2A}"/>
                </a:ext>
              </a:extLst>
            </p:cNvPr>
            <p:cNvGrpSpPr/>
            <p:nvPr/>
          </p:nvGrpSpPr>
          <p:grpSpPr>
            <a:xfrm>
              <a:off x="7463232" y="9188179"/>
              <a:ext cx="7579978" cy="5321475"/>
              <a:chOff x="14145344" y="945413"/>
              <a:chExt cx="4206327" cy="2953025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A669411-0A7E-4419-E6A5-00321F5EEA69}"/>
                  </a:ext>
                </a:extLst>
              </p:cNvPr>
              <p:cNvSpPr txBox="1"/>
              <p:nvPr/>
            </p:nvSpPr>
            <p:spPr>
              <a:xfrm>
                <a:off x="14145344" y="1546304"/>
                <a:ext cx="591524" cy="222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1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7620A64-BBD1-BBDC-4FE3-A58B2DAD6D75}"/>
                  </a:ext>
                </a:extLst>
              </p:cNvPr>
              <p:cNvSpPr txBox="1"/>
              <p:nvPr/>
            </p:nvSpPr>
            <p:spPr>
              <a:xfrm>
                <a:off x="14145344" y="3082009"/>
                <a:ext cx="591524" cy="222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2</a:t>
                </a:r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73AAB5F4-DA9D-3093-2F8E-9D199791AC44}"/>
                  </a:ext>
                </a:extLst>
              </p:cNvPr>
              <p:cNvGrpSpPr/>
              <p:nvPr/>
            </p:nvGrpSpPr>
            <p:grpSpPr>
              <a:xfrm>
                <a:off x="14579253" y="945413"/>
                <a:ext cx="3772418" cy="2953025"/>
                <a:chOff x="10300444" y="1366892"/>
                <a:chExt cx="3772418" cy="2953025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E89A3064-C752-A8DE-638B-A35B277001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2749797" y="1366892"/>
                  <a:ext cx="1323065" cy="1417320"/>
                </a:xfrm>
                <a:prstGeom prst="rect">
                  <a:avLst/>
                </a:prstGeom>
              </p:spPr>
            </p:pic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5F8CCF3E-2FA6-A75B-6B6A-837A1F081B1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1528007" y="1366892"/>
                  <a:ext cx="1323065" cy="1417320"/>
                </a:xfrm>
                <a:prstGeom prst="rect">
                  <a:avLst/>
                </a:prstGeom>
              </p:spPr>
            </p:pic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AAE80363-3B5C-1A9C-452C-53D7B39210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0302697" y="1366892"/>
                  <a:ext cx="1326555" cy="141732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C2CB988E-6CFA-08C3-7796-8A7F587927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0300444" y="2902597"/>
                  <a:ext cx="1326555" cy="1417320"/>
                </a:xfrm>
                <a:prstGeom prst="rect">
                  <a:avLst/>
                </a:prstGeom>
              </p:spPr>
            </p:pic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2D344315-7A10-8B75-4BB5-6896EEA6BC7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11557430" y="2902597"/>
                  <a:ext cx="1291647" cy="1417320"/>
                </a:xfrm>
                <a:prstGeom prst="rect">
                  <a:avLst/>
                </a:prstGeom>
              </p:spPr>
            </p:pic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2E56DB7D-DEA3-B08D-8BA9-1E058139B5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12744023" y="2902597"/>
                  <a:ext cx="1326555" cy="1417320"/>
                </a:xfrm>
                <a:prstGeom prst="rect">
                  <a:avLst/>
                </a:prstGeom>
              </p:spPr>
            </p:pic>
          </p:grp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652AB18-6A0D-BAA9-5872-B6C148BD2692}"/>
                </a:ext>
              </a:extLst>
            </p:cNvPr>
            <p:cNvSpPr txBox="1"/>
            <p:nvPr/>
          </p:nvSpPr>
          <p:spPr>
            <a:xfrm>
              <a:off x="9812978" y="8763101"/>
              <a:ext cx="3982208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REGROWN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E27A2E92-6AA5-D137-6590-6FEAC20EB3DA}"/>
              </a:ext>
            </a:extLst>
          </p:cNvPr>
          <p:cNvGrpSpPr/>
          <p:nvPr/>
        </p:nvGrpSpPr>
        <p:grpSpPr>
          <a:xfrm>
            <a:off x="378546" y="8763101"/>
            <a:ext cx="7469994" cy="5742005"/>
            <a:chOff x="378546" y="8763101"/>
            <a:chExt cx="7469994" cy="5742005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93598FA8-6D03-5AF2-5932-9660378BD592}"/>
                </a:ext>
              </a:extLst>
            </p:cNvPr>
            <p:cNvGrpSpPr/>
            <p:nvPr/>
          </p:nvGrpSpPr>
          <p:grpSpPr>
            <a:xfrm>
              <a:off x="378546" y="9204119"/>
              <a:ext cx="7469994" cy="5300987"/>
              <a:chOff x="14087206" y="4090603"/>
              <a:chExt cx="4145294" cy="2941656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BB3FE61D-BD98-41CE-4662-12D989FEE3A2}"/>
                  </a:ext>
                </a:extLst>
              </p:cNvPr>
              <p:cNvGrpSpPr/>
              <p:nvPr/>
            </p:nvGrpSpPr>
            <p:grpSpPr>
              <a:xfrm>
                <a:off x="14520974" y="4090603"/>
                <a:ext cx="3711526" cy="2941656"/>
                <a:chOff x="8858313" y="1261622"/>
                <a:chExt cx="3711526" cy="2941656"/>
              </a:xfrm>
            </p:grpSpPr>
            <p:pic>
              <p:nvPicPr>
                <p:cNvPr id="25" name="Picture 24">
                  <a:extLst>
                    <a:ext uri="{FF2B5EF4-FFF2-40B4-BE49-F238E27FC236}">
                      <a16:creationId xmlns:a16="http://schemas.microsoft.com/office/drawing/2014/main" id="{020C156A-97F8-6F6D-63C6-990CFFF1492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8858313" y="1263368"/>
                  <a:ext cx="1323430" cy="1414219"/>
                </a:xfrm>
                <a:prstGeom prst="rect">
                  <a:avLst/>
                </a:prstGeom>
              </p:spPr>
            </p:pic>
            <p:pic>
              <p:nvPicPr>
                <p:cNvPr id="26" name="Picture 25">
                  <a:extLst>
                    <a:ext uri="{FF2B5EF4-FFF2-40B4-BE49-F238E27FC236}">
                      <a16:creationId xmlns:a16="http://schemas.microsoft.com/office/drawing/2014/main" id="{21A25CFC-2299-02A5-26B8-CD709EC5B9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10062280" y="1261622"/>
                  <a:ext cx="1323430" cy="1417711"/>
                </a:xfrm>
                <a:prstGeom prst="rect">
                  <a:avLst/>
                </a:prstGeom>
              </p:spPr>
            </p:pic>
            <p:pic>
              <p:nvPicPr>
                <p:cNvPr id="27" name="Picture 26">
                  <a:extLst>
                    <a:ext uri="{FF2B5EF4-FFF2-40B4-BE49-F238E27FC236}">
                      <a16:creationId xmlns:a16="http://schemas.microsoft.com/office/drawing/2014/main" id="{A99683FA-D664-1721-10EE-E367894398B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1266247" y="1261622"/>
                  <a:ext cx="1292003" cy="1417711"/>
                </a:xfrm>
                <a:prstGeom prst="rect">
                  <a:avLst/>
                </a:prstGeom>
              </p:spPr>
            </p:pic>
            <p:pic>
              <p:nvPicPr>
                <p:cNvPr id="28" name="Picture 27">
                  <a:extLst>
                    <a:ext uri="{FF2B5EF4-FFF2-40B4-BE49-F238E27FC236}">
                      <a16:creationId xmlns:a16="http://schemas.microsoft.com/office/drawing/2014/main" id="{461EB57C-3C1D-673A-55AB-B5EEDDC1AF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8866410" y="2785567"/>
                  <a:ext cx="1326922" cy="1417711"/>
                </a:xfrm>
                <a:prstGeom prst="rect">
                  <a:avLst/>
                </a:prstGeom>
              </p:spPr>
            </p:pic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E874FE1E-7DF5-7940-8FC4-9BBF95653F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10070377" y="2785567"/>
                  <a:ext cx="1326922" cy="1417711"/>
                </a:xfrm>
                <a:prstGeom prst="rect">
                  <a:avLst/>
                </a:prstGeom>
              </p:spPr>
            </p:pic>
            <p:pic>
              <p:nvPicPr>
                <p:cNvPr id="30" name="Picture 29">
                  <a:extLst>
                    <a:ext uri="{FF2B5EF4-FFF2-40B4-BE49-F238E27FC236}">
                      <a16:creationId xmlns:a16="http://schemas.microsoft.com/office/drawing/2014/main" id="{705FBB4D-C243-E301-1E8B-BBD51AD846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11277836" y="2785567"/>
                  <a:ext cx="1292003" cy="1417711"/>
                </a:xfrm>
                <a:prstGeom prst="rect">
                  <a:avLst/>
                </a:prstGeom>
              </p:spPr>
            </p:pic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5CD7CBD-F8F4-620A-9F00-14BDBD80A305}"/>
                  </a:ext>
                </a:extLst>
              </p:cNvPr>
              <p:cNvSpPr txBox="1"/>
              <p:nvPr/>
            </p:nvSpPr>
            <p:spPr>
              <a:xfrm>
                <a:off x="14087206" y="4691686"/>
                <a:ext cx="591524" cy="222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1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38524A7-58B0-77B0-C1F2-CD53EAAA8313}"/>
                  </a:ext>
                </a:extLst>
              </p:cNvPr>
              <p:cNvSpPr txBox="1"/>
              <p:nvPr/>
            </p:nvSpPr>
            <p:spPr>
              <a:xfrm>
                <a:off x="14087206" y="6215634"/>
                <a:ext cx="591524" cy="222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2</a:t>
                </a:r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5CD1046-1806-6560-D277-7A74E283FD16}"/>
                </a:ext>
              </a:extLst>
            </p:cNvPr>
            <p:cNvSpPr txBox="1"/>
            <p:nvPr/>
          </p:nvSpPr>
          <p:spPr>
            <a:xfrm>
              <a:off x="2598264" y="8763101"/>
              <a:ext cx="3713242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AL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99C94C01-6FB2-F691-C39E-F2FB8293BC6F}"/>
              </a:ext>
            </a:extLst>
          </p:cNvPr>
          <p:cNvSpPr txBox="1"/>
          <p:nvPr/>
        </p:nvSpPr>
        <p:spPr>
          <a:xfrm rot="10800000" flipH="1" flipV="1">
            <a:off x="22526" y="285271"/>
            <a:ext cx="897915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24E53CB-B0A1-E54E-D486-6EEF6DF2369C}"/>
              </a:ext>
            </a:extLst>
          </p:cNvPr>
          <p:cNvGrpSpPr/>
          <p:nvPr/>
        </p:nvGrpSpPr>
        <p:grpSpPr>
          <a:xfrm>
            <a:off x="8448128" y="211558"/>
            <a:ext cx="1800154" cy="1711797"/>
            <a:chOff x="6647392" y="718449"/>
            <a:chExt cx="1860484" cy="1769166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EC552889-501E-6E2A-8A5E-89A524C129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7282" b="7746"/>
            <a:stretch/>
          </p:blipFill>
          <p:spPr>
            <a:xfrm>
              <a:off x="6647392" y="718449"/>
              <a:ext cx="1860484" cy="1769166"/>
            </a:xfrm>
            <a:prstGeom prst="rect">
              <a:avLst/>
            </a:prstGeom>
          </p:spPr>
        </p:pic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12515867-FFB6-BDD9-8421-159D4F24C966}"/>
                </a:ext>
              </a:extLst>
            </p:cNvPr>
            <p:cNvSpPr/>
            <p:nvPr/>
          </p:nvSpPr>
          <p:spPr>
            <a:xfrm flipH="1" flipV="1">
              <a:off x="6924104" y="819478"/>
              <a:ext cx="175634" cy="1282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448A8DFF-D4A5-7B66-60EA-679CFDDC58FA}"/>
                </a:ext>
              </a:extLst>
            </p:cNvPr>
            <p:cNvSpPr/>
            <p:nvPr/>
          </p:nvSpPr>
          <p:spPr>
            <a:xfrm flipH="1" flipV="1">
              <a:off x="8290449" y="819477"/>
              <a:ext cx="175634" cy="1282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58CCFBB7-E461-DF10-BECE-41285E700E44}"/>
              </a:ext>
            </a:extLst>
          </p:cNvPr>
          <p:cNvGrpSpPr/>
          <p:nvPr/>
        </p:nvGrpSpPr>
        <p:grpSpPr>
          <a:xfrm>
            <a:off x="8715866" y="1923354"/>
            <a:ext cx="1529595" cy="383213"/>
            <a:chOff x="2137881" y="9437502"/>
            <a:chExt cx="1944526" cy="487167"/>
          </a:xfrm>
        </p:grpSpPr>
        <p:sp>
          <p:nvSpPr>
            <p:cNvPr id="40" name="Up Arrow 39">
              <a:extLst>
                <a:ext uri="{FF2B5EF4-FFF2-40B4-BE49-F238E27FC236}">
                  <a16:creationId xmlns:a16="http://schemas.microsoft.com/office/drawing/2014/main" id="{44F5D873-1EF1-63E3-7CC0-94ED0E4D7EB3}"/>
                </a:ext>
              </a:extLst>
            </p:cNvPr>
            <p:cNvSpPr/>
            <p:nvPr/>
          </p:nvSpPr>
          <p:spPr>
            <a:xfrm rot="5400000">
              <a:off x="3044298" y="8531085"/>
              <a:ext cx="131692" cy="1944526"/>
            </a:xfrm>
            <a:prstGeom prst="upArrow">
              <a:avLst>
                <a:gd name="adj1" fmla="val 34646"/>
                <a:gd name="adj2" fmla="val 86466"/>
              </a:avLst>
            </a:prstGeom>
            <a:solidFill>
              <a:schemeClr val="tx1"/>
            </a:solidFill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34E86F8-C51A-1A76-A2EF-3891241089F0}"/>
                </a:ext>
              </a:extLst>
            </p:cNvPr>
            <p:cNvSpPr txBox="1"/>
            <p:nvPr/>
          </p:nvSpPr>
          <p:spPr>
            <a:xfrm>
              <a:off x="2541719" y="9494276"/>
              <a:ext cx="1312782" cy="43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II+</a:t>
              </a: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5698B530-BD44-CFE9-C6DB-10C537FB1D6C}"/>
              </a:ext>
            </a:extLst>
          </p:cNvPr>
          <p:cNvSpPr txBox="1"/>
          <p:nvPr/>
        </p:nvSpPr>
        <p:spPr>
          <a:xfrm>
            <a:off x="9583484" y="211558"/>
            <a:ext cx="7152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4.5%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A3CFA90F-C1C4-04B8-C91A-5230B4ED6D8D}"/>
              </a:ext>
            </a:extLst>
          </p:cNvPr>
          <p:cNvGrpSpPr/>
          <p:nvPr/>
        </p:nvGrpSpPr>
        <p:grpSpPr>
          <a:xfrm>
            <a:off x="342323" y="2193412"/>
            <a:ext cx="6733686" cy="4881588"/>
            <a:chOff x="355771" y="3566226"/>
            <a:chExt cx="6948179" cy="5037085"/>
          </a:xfrm>
        </p:grpSpPr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40FB7E08-3454-0624-E7DB-38BC065DACC4}"/>
                </a:ext>
              </a:extLst>
            </p:cNvPr>
            <p:cNvGrpSpPr/>
            <p:nvPr/>
          </p:nvGrpSpPr>
          <p:grpSpPr>
            <a:xfrm>
              <a:off x="2048180" y="5895217"/>
              <a:ext cx="2348102" cy="2207793"/>
              <a:chOff x="1945261" y="8664327"/>
              <a:chExt cx="2348102" cy="2207793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A5408252-0162-06B9-B996-BE44DC97226E}"/>
                  </a:ext>
                </a:extLst>
              </p:cNvPr>
              <p:cNvGrpSpPr/>
              <p:nvPr/>
            </p:nvGrpSpPr>
            <p:grpSpPr>
              <a:xfrm>
                <a:off x="1945261" y="8688373"/>
                <a:ext cx="2283951" cy="2183747"/>
                <a:chOff x="1910800" y="7098396"/>
                <a:chExt cx="1856803" cy="1775340"/>
              </a:xfrm>
            </p:grpSpPr>
            <p:pic>
              <p:nvPicPr>
                <p:cNvPr id="83" name="Picture 82">
                  <a:extLst>
                    <a:ext uri="{FF2B5EF4-FFF2-40B4-BE49-F238E27FC236}">
                      <a16:creationId xmlns:a16="http://schemas.microsoft.com/office/drawing/2014/main" id="{6A2790B7-4863-9331-F02B-8AADE1EDAD5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/>
                <a:srcRect l="7465" b="7423"/>
                <a:stretch/>
              </p:blipFill>
              <p:spPr>
                <a:xfrm>
                  <a:off x="1910800" y="7098396"/>
                  <a:ext cx="1856803" cy="1775340"/>
                </a:xfrm>
                <a:prstGeom prst="rect">
                  <a:avLst/>
                </a:prstGeom>
              </p:spPr>
            </p:pic>
            <p:sp>
              <p:nvSpPr>
                <p:cNvPr id="84" name="Rectangle 83">
                  <a:extLst>
                    <a:ext uri="{FF2B5EF4-FFF2-40B4-BE49-F238E27FC236}">
                      <a16:creationId xmlns:a16="http://schemas.microsoft.com/office/drawing/2014/main" id="{7157B165-4B60-C65C-70E1-3434D5CA8DA1}"/>
                    </a:ext>
                  </a:extLst>
                </p:cNvPr>
                <p:cNvSpPr/>
                <p:nvPr/>
              </p:nvSpPr>
              <p:spPr>
                <a:xfrm flipH="1" flipV="1">
                  <a:off x="3502987" y="7228977"/>
                  <a:ext cx="238342" cy="962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C19D760D-633F-579C-079B-8AF50DAF3C79}"/>
                  </a:ext>
                </a:extLst>
              </p:cNvPr>
              <p:cNvSpPr txBox="1"/>
              <p:nvPr/>
            </p:nvSpPr>
            <p:spPr>
              <a:xfrm>
                <a:off x="3384076" y="8664327"/>
                <a:ext cx="909287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.7%</a:t>
                </a:r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7B1EE51C-836E-1067-52E6-DD2A996E575A}"/>
                </a:ext>
              </a:extLst>
            </p:cNvPr>
            <p:cNvGrpSpPr/>
            <p:nvPr/>
          </p:nvGrpSpPr>
          <p:grpSpPr>
            <a:xfrm>
              <a:off x="4856615" y="5895217"/>
              <a:ext cx="2447335" cy="2207793"/>
              <a:chOff x="4922677" y="8664327"/>
              <a:chExt cx="2447335" cy="2207793"/>
            </a:xfrm>
          </p:grpSpPr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DC8C56B4-8E51-C053-A149-B199155D9ACD}"/>
                  </a:ext>
                </a:extLst>
              </p:cNvPr>
              <p:cNvGrpSpPr/>
              <p:nvPr/>
            </p:nvGrpSpPr>
            <p:grpSpPr>
              <a:xfrm>
                <a:off x="4922677" y="8664327"/>
                <a:ext cx="2244856" cy="2207793"/>
                <a:chOff x="4922677" y="8664327"/>
                <a:chExt cx="2244856" cy="2207793"/>
              </a:xfrm>
            </p:grpSpPr>
            <p:pic>
              <p:nvPicPr>
                <p:cNvPr id="79" name="Picture 78">
                  <a:extLst>
                    <a:ext uri="{FF2B5EF4-FFF2-40B4-BE49-F238E27FC236}">
                      <a16:creationId xmlns:a16="http://schemas.microsoft.com/office/drawing/2014/main" id="{01E3E053-C096-1528-9B1B-6D5019A59B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/>
                <a:srcRect l="7289" t="2841" b="7140"/>
                <a:stretch/>
              </p:blipFill>
              <p:spPr>
                <a:xfrm>
                  <a:off x="4922677" y="8664327"/>
                  <a:ext cx="2244856" cy="2207793"/>
                </a:xfrm>
                <a:prstGeom prst="rect">
                  <a:avLst/>
                </a:prstGeom>
              </p:spPr>
            </p:pic>
            <p:sp>
              <p:nvSpPr>
                <p:cNvPr id="80" name="Rectangle 79">
                  <a:extLst>
                    <a:ext uri="{FF2B5EF4-FFF2-40B4-BE49-F238E27FC236}">
                      <a16:creationId xmlns:a16="http://schemas.microsoft.com/office/drawing/2014/main" id="{C60A9E97-8B37-4B8E-96C1-53B85152D53F}"/>
                    </a:ext>
                  </a:extLst>
                </p:cNvPr>
                <p:cNvSpPr/>
                <p:nvPr/>
              </p:nvSpPr>
              <p:spPr>
                <a:xfrm flipH="1" flipV="1">
                  <a:off x="6813868" y="8750415"/>
                  <a:ext cx="218891" cy="21696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7977D369-E65F-677C-8906-4F91E3CEDF73}"/>
                  </a:ext>
                </a:extLst>
              </p:cNvPr>
              <p:cNvSpPr txBox="1"/>
              <p:nvPr/>
            </p:nvSpPr>
            <p:spPr>
              <a:xfrm>
                <a:off x="6269067" y="8688373"/>
                <a:ext cx="1100945" cy="4303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.9%</a:t>
                </a:r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981753E0-8AA2-0B1F-3EB0-BB7C59498320}"/>
                </a:ext>
              </a:extLst>
            </p:cNvPr>
            <p:cNvGrpSpPr/>
            <p:nvPr/>
          </p:nvGrpSpPr>
          <p:grpSpPr>
            <a:xfrm>
              <a:off x="4856615" y="3566226"/>
              <a:ext cx="2333220" cy="2197298"/>
              <a:chOff x="4922677" y="3330968"/>
              <a:chExt cx="2333220" cy="2197298"/>
            </a:xfrm>
          </p:grpSpPr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C7DC99EF-3618-5050-91B5-2299E5E40A79}"/>
                  </a:ext>
                </a:extLst>
              </p:cNvPr>
              <p:cNvGrpSpPr/>
              <p:nvPr/>
            </p:nvGrpSpPr>
            <p:grpSpPr>
              <a:xfrm>
                <a:off x="4922677" y="3330968"/>
                <a:ext cx="2244856" cy="2197298"/>
                <a:chOff x="4922677" y="3330968"/>
                <a:chExt cx="2244856" cy="2197298"/>
              </a:xfrm>
            </p:grpSpPr>
            <p:pic>
              <p:nvPicPr>
                <p:cNvPr id="75" name="Picture 74">
                  <a:extLst>
                    <a:ext uri="{FF2B5EF4-FFF2-40B4-BE49-F238E27FC236}">
                      <a16:creationId xmlns:a16="http://schemas.microsoft.com/office/drawing/2014/main" id="{CF12D4CB-0E42-8945-1D52-E0E095EE9D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/>
                <a:srcRect l="7289" t="3269" b="7141"/>
                <a:stretch/>
              </p:blipFill>
              <p:spPr>
                <a:xfrm>
                  <a:off x="4922677" y="3330968"/>
                  <a:ext cx="2244856" cy="2197298"/>
                </a:xfrm>
                <a:prstGeom prst="rect">
                  <a:avLst/>
                </a:prstGeom>
              </p:spPr>
            </p:pic>
            <p:sp>
              <p:nvSpPr>
                <p:cNvPr id="76" name="Rectangle 75">
                  <a:extLst>
                    <a:ext uri="{FF2B5EF4-FFF2-40B4-BE49-F238E27FC236}">
                      <a16:creationId xmlns:a16="http://schemas.microsoft.com/office/drawing/2014/main" id="{E8F56CBE-D9C1-248B-4720-CFFB4F1E0FEB}"/>
                    </a:ext>
                  </a:extLst>
                </p:cNvPr>
                <p:cNvSpPr/>
                <p:nvPr/>
              </p:nvSpPr>
              <p:spPr>
                <a:xfrm flipH="1" flipV="1">
                  <a:off x="6747805" y="3391684"/>
                  <a:ext cx="353665" cy="21696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152C6643-7E6A-49D4-3204-99A560BDFE02}"/>
                  </a:ext>
                </a:extLst>
              </p:cNvPr>
              <p:cNvSpPr txBox="1"/>
              <p:nvPr/>
            </p:nvSpPr>
            <p:spPr>
              <a:xfrm>
                <a:off x="6291267" y="3330968"/>
                <a:ext cx="964630" cy="4303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2.6%</a:t>
                </a:r>
              </a:p>
            </p:txBody>
          </p: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AC17FB65-69A1-99AB-EB09-0B3C1F97B082}"/>
                </a:ext>
              </a:extLst>
            </p:cNvPr>
            <p:cNvGrpSpPr/>
            <p:nvPr/>
          </p:nvGrpSpPr>
          <p:grpSpPr>
            <a:xfrm>
              <a:off x="2012027" y="3579777"/>
              <a:ext cx="2409837" cy="2183747"/>
              <a:chOff x="1909108" y="3344519"/>
              <a:chExt cx="2409837" cy="2183747"/>
            </a:xfrm>
          </p:grpSpPr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958D3582-A5C3-3524-25B4-CFEC375766AA}"/>
                  </a:ext>
                </a:extLst>
              </p:cNvPr>
              <p:cNvGrpSpPr/>
              <p:nvPr/>
            </p:nvGrpSpPr>
            <p:grpSpPr>
              <a:xfrm>
                <a:off x="1909108" y="3344519"/>
                <a:ext cx="2320104" cy="2183747"/>
                <a:chOff x="1881409" y="2853388"/>
                <a:chExt cx="1886195" cy="1775340"/>
              </a:xfrm>
            </p:grpSpPr>
            <p:pic>
              <p:nvPicPr>
                <p:cNvPr id="71" name="Picture 70">
                  <a:extLst>
                    <a:ext uri="{FF2B5EF4-FFF2-40B4-BE49-F238E27FC236}">
                      <a16:creationId xmlns:a16="http://schemas.microsoft.com/office/drawing/2014/main" id="{7D633998-87C3-4B51-345E-968DFFE860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/>
                <a:srcRect l="6000" b="7423"/>
                <a:stretch/>
              </p:blipFill>
              <p:spPr>
                <a:xfrm>
                  <a:off x="1881409" y="2853388"/>
                  <a:ext cx="1886195" cy="1775340"/>
                </a:xfrm>
                <a:prstGeom prst="rect">
                  <a:avLst/>
                </a:prstGeom>
              </p:spPr>
            </p:pic>
            <p:sp>
              <p:nvSpPr>
                <p:cNvPr id="72" name="Rectangle 71">
                  <a:extLst>
                    <a:ext uri="{FF2B5EF4-FFF2-40B4-BE49-F238E27FC236}">
                      <a16:creationId xmlns:a16="http://schemas.microsoft.com/office/drawing/2014/main" id="{FBFBA902-C8DB-948A-4D80-534F678BAB26}"/>
                    </a:ext>
                  </a:extLst>
                </p:cNvPr>
                <p:cNvSpPr/>
                <p:nvPr/>
              </p:nvSpPr>
              <p:spPr>
                <a:xfrm flipH="1" flipV="1">
                  <a:off x="3475555" y="2992501"/>
                  <a:ext cx="238342" cy="962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654E1064-9E19-1382-FE54-0510236A5A89}"/>
                  </a:ext>
                </a:extLst>
              </p:cNvPr>
              <p:cNvSpPr txBox="1"/>
              <p:nvPr/>
            </p:nvSpPr>
            <p:spPr>
              <a:xfrm>
                <a:off x="3409658" y="3344519"/>
                <a:ext cx="909287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2.9%</a:t>
                </a:r>
              </a:p>
            </p:txBody>
          </p:sp>
        </p:grp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85AAA24-171B-304F-5D70-00DF2F3DB9D9}"/>
                </a:ext>
              </a:extLst>
            </p:cNvPr>
            <p:cNvSpPr txBox="1"/>
            <p:nvPr/>
          </p:nvSpPr>
          <p:spPr>
            <a:xfrm>
              <a:off x="355771" y="6717677"/>
              <a:ext cx="1571692" cy="412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platin</a:t>
              </a:r>
            </a:p>
          </p:txBody>
        </p: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3EB3AEAA-F312-8813-AAC5-C5C694441664}"/>
                </a:ext>
              </a:extLst>
            </p:cNvPr>
            <p:cNvGrpSpPr/>
            <p:nvPr/>
          </p:nvGrpSpPr>
          <p:grpSpPr>
            <a:xfrm>
              <a:off x="2314874" y="8103010"/>
              <a:ext cx="1944526" cy="500301"/>
              <a:chOff x="2137881" y="9437502"/>
              <a:chExt cx="1944526" cy="500301"/>
            </a:xfrm>
          </p:grpSpPr>
          <p:sp>
            <p:nvSpPr>
              <p:cNvPr id="67" name="Up Arrow 66">
                <a:extLst>
                  <a:ext uri="{FF2B5EF4-FFF2-40B4-BE49-F238E27FC236}">
                    <a16:creationId xmlns:a16="http://schemas.microsoft.com/office/drawing/2014/main" id="{7C443226-B2B2-F296-C6EB-5E3259A16B63}"/>
                  </a:ext>
                </a:extLst>
              </p:cNvPr>
              <p:cNvSpPr/>
              <p:nvPr/>
            </p:nvSpPr>
            <p:spPr>
              <a:xfrm rot="5400000">
                <a:off x="3044298" y="8531085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8715C28A-60C3-C5BB-5EFD-FB07FDF92CE4}"/>
                  </a:ext>
                </a:extLst>
              </p:cNvPr>
              <p:cNvSpPr txBox="1"/>
              <p:nvPr/>
            </p:nvSpPr>
            <p:spPr>
              <a:xfrm>
                <a:off x="2669960" y="9507410"/>
                <a:ext cx="1019332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5+</a:t>
                </a:r>
              </a:p>
            </p:txBody>
          </p:sp>
        </p:grp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28AB39DF-04F9-CDBE-EEA8-018837C6D065}"/>
                </a:ext>
              </a:extLst>
            </p:cNvPr>
            <p:cNvGrpSpPr/>
            <p:nvPr/>
          </p:nvGrpSpPr>
          <p:grpSpPr>
            <a:xfrm>
              <a:off x="1575613" y="3579777"/>
              <a:ext cx="468536" cy="4350816"/>
              <a:chOff x="1479361" y="4914269"/>
              <a:chExt cx="468536" cy="4350816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885FBD3C-2089-89FE-B1D0-880419B43D30}"/>
                  </a:ext>
                </a:extLst>
              </p:cNvPr>
              <p:cNvSpPr txBox="1"/>
              <p:nvPr/>
            </p:nvSpPr>
            <p:spPr>
              <a:xfrm rot="16200000">
                <a:off x="1201194" y="6874482"/>
                <a:ext cx="986727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</a:p>
            </p:txBody>
          </p:sp>
          <p:sp>
            <p:nvSpPr>
              <p:cNvPr id="66" name="Up Arrow 65">
                <a:extLst>
                  <a:ext uri="{FF2B5EF4-FFF2-40B4-BE49-F238E27FC236}">
                    <a16:creationId xmlns:a16="http://schemas.microsoft.com/office/drawing/2014/main" id="{2F991FA1-725D-7CE2-E08D-CE88947D366B}"/>
                  </a:ext>
                </a:extLst>
              </p:cNvPr>
              <p:cNvSpPr/>
              <p:nvPr/>
            </p:nvSpPr>
            <p:spPr>
              <a:xfrm>
                <a:off x="1816206" y="4914269"/>
                <a:ext cx="131691" cy="435081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2CAAB565-7285-6F57-8D20-AB35F870B33A}"/>
                </a:ext>
              </a:extLst>
            </p:cNvPr>
            <p:cNvGrpSpPr/>
            <p:nvPr/>
          </p:nvGrpSpPr>
          <p:grpSpPr>
            <a:xfrm>
              <a:off x="5117157" y="8103010"/>
              <a:ext cx="1944526" cy="500301"/>
              <a:chOff x="2137881" y="9437502"/>
              <a:chExt cx="1944526" cy="500301"/>
            </a:xfrm>
          </p:grpSpPr>
          <p:sp>
            <p:nvSpPr>
              <p:cNvPr id="63" name="Up Arrow 62">
                <a:extLst>
                  <a:ext uri="{FF2B5EF4-FFF2-40B4-BE49-F238E27FC236}">
                    <a16:creationId xmlns:a16="http://schemas.microsoft.com/office/drawing/2014/main" id="{0DF1BB86-A9AF-7152-75AC-3681D45D075C}"/>
                  </a:ext>
                </a:extLst>
              </p:cNvPr>
              <p:cNvSpPr/>
              <p:nvPr/>
            </p:nvSpPr>
            <p:spPr>
              <a:xfrm rot="5400000">
                <a:off x="3044298" y="8531085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5EE25F90-FCBE-E9E3-EC23-1317A1189BA6}"/>
                  </a:ext>
                </a:extLst>
              </p:cNvPr>
              <p:cNvSpPr txBox="1"/>
              <p:nvPr/>
            </p:nvSpPr>
            <p:spPr>
              <a:xfrm>
                <a:off x="2669960" y="9507410"/>
                <a:ext cx="1007105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4/80+</a:t>
                </a:r>
              </a:p>
            </p:txBody>
          </p: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53607700-0630-2418-D985-661E77BBB1DD}"/>
                </a:ext>
              </a:extLst>
            </p:cNvPr>
            <p:cNvGrpSpPr/>
            <p:nvPr/>
          </p:nvGrpSpPr>
          <p:grpSpPr>
            <a:xfrm>
              <a:off x="4377898" y="3579777"/>
              <a:ext cx="468534" cy="4350816"/>
              <a:chOff x="4377898" y="4914269"/>
              <a:chExt cx="468534" cy="4350816"/>
            </a:xfrm>
          </p:grpSpPr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A4133B51-EEB4-F138-D0D7-23DF25D7F3D4}"/>
                  </a:ext>
                </a:extLst>
              </p:cNvPr>
              <p:cNvSpPr txBox="1"/>
              <p:nvPr/>
            </p:nvSpPr>
            <p:spPr>
              <a:xfrm rot="16200000">
                <a:off x="4018299" y="6874482"/>
                <a:ext cx="1149591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1b+</a:t>
                </a:r>
              </a:p>
            </p:txBody>
          </p:sp>
          <p:sp>
            <p:nvSpPr>
              <p:cNvPr id="62" name="Up Arrow 61">
                <a:extLst>
                  <a:ext uri="{FF2B5EF4-FFF2-40B4-BE49-F238E27FC236}">
                    <a16:creationId xmlns:a16="http://schemas.microsoft.com/office/drawing/2014/main" id="{34F7A243-53C3-4800-4E2F-D5FE5BA602EA}"/>
                  </a:ext>
                </a:extLst>
              </p:cNvPr>
              <p:cNvSpPr/>
              <p:nvPr/>
            </p:nvSpPr>
            <p:spPr>
              <a:xfrm>
                <a:off x="4714741" y="4914269"/>
                <a:ext cx="131691" cy="435081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E4966E6-4793-0021-210F-A4765B142C57}"/>
                </a:ext>
              </a:extLst>
            </p:cNvPr>
            <p:cNvSpPr txBox="1"/>
            <p:nvPr/>
          </p:nvSpPr>
          <p:spPr>
            <a:xfrm>
              <a:off x="924239" y="4440817"/>
              <a:ext cx="1003224" cy="412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</a:p>
          </p:txBody>
        </p: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FCF38BBE-4E67-396E-8A1E-434FCDF4A3F3}"/>
              </a:ext>
            </a:extLst>
          </p:cNvPr>
          <p:cNvGrpSpPr/>
          <p:nvPr/>
        </p:nvGrpSpPr>
        <p:grpSpPr>
          <a:xfrm>
            <a:off x="10182214" y="211558"/>
            <a:ext cx="2129482" cy="2095009"/>
            <a:chOff x="9975967" y="718449"/>
            <a:chExt cx="2707143" cy="2663319"/>
          </a:xfrm>
        </p:grpSpPr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FBC7B1B7-251D-4C6F-5D54-6F976B5C9B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7802" b="7746"/>
            <a:stretch/>
          </p:blipFill>
          <p:spPr>
            <a:xfrm>
              <a:off x="10450681" y="718449"/>
              <a:ext cx="2232429" cy="2176152"/>
            </a:xfrm>
            <a:prstGeom prst="rect">
              <a:avLst/>
            </a:prstGeom>
          </p:spPr>
        </p:pic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BCE4FE61-B28B-85AF-BA69-36976DB06A98}"/>
                </a:ext>
              </a:extLst>
            </p:cNvPr>
            <p:cNvGrpSpPr/>
            <p:nvPr/>
          </p:nvGrpSpPr>
          <p:grpSpPr>
            <a:xfrm>
              <a:off x="10738584" y="2894601"/>
              <a:ext cx="1944526" cy="487167"/>
              <a:chOff x="2137881" y="9437502"/>
              <a:chExt cx="1944526" cy="487167"/>
            </a:xfrm>
          </p:grpSpPr>
          <p:sp>
            <p:nvSpPr>
              <p:cNvPr id="91" name="Up Arrow 90">
                <a:extLst>
                  <a:ext uri="{FF2B5EF4-FFF2-40B4-BE49-F238E27FC236}">
                    <a16:creationId xmlns:a16="http://schemas.microsoft.com/office/drawing/2014/main" id="{CDB3DAA9-CDA6-2410-73B6-D7FAFC1FDCE3}"/>
                  </a:ext>
                </a:extLst>
              </p:cNvPr>
              <p:cNvSpPr/>
              <p:nvPr/>
            </p:nvSpPr>
            <p:spPr>
              <a:xfrm rot="5400000">
                <a:off x="3044298" y="8531085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A2061481-3D0F-FE61-B6D5-08FD232BD7EB}"/>
                  </a:ext>
                </a:extLst>
              </p:cNvPr>
              <p:cNvSpPr txBox="1"/>
              <p:nvPr/>
            </p:nvSpPr>
            <p:spPr>
              <a:xfrm>
                <a:off x="2669960" y="9494276"/>
                <a:ext cx="1019332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0+</a:t>
                </a:r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8B8A66D1-6947-0BEC-6143-52B37DD81153}"/>
                </a:ext>
              </a:extLst>
            </p:cNvPr>
            <p:cNvGrpSpPr/>
            <p:nvPr/>
          </p:nvGrpSpPr>
          <p:grpSpPr>
            <a:xfrm>
              <a:off x="9975967" y="718449"/>
              <a:ext cx="474714" cy="1944526"/>
              <a:chOff x="7296764" y="718449"/>
              <a:chExt cx="474714" cy="1944526"/>
            </a:xfrm>
          </p:grpSpPr>
          <p:sp>
            <p:nvSpPr>
              <p:cNvPr id="89" name="Up Arrow 88">
                <a:extLst>
                  <a:ext uri="{FF2B5EF4-FFF2-40B4-BE49-F238E27FC236}">
                    <a16:creationId xmlns:a16="http://schemas.microsoft.com/office/drawing/2014/main" id="{AF4B6026-EEFB-A9B1-2D38-561C0384E25A}"/>
                  </a:ext>
                </a:extLst>
              </p:cNvPr>
              <p:cNvSpPr/>
              <p:nvPr/>
            </p:nvSpPr>
            <p:spPr>
              <a:xfrm>
                <a:off x="7639786" y="718449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03B53A91-5D4D-3F70-3278-F0597A582FB7}"/>
                  </a:ext>
                </a:extLst>
              </p:cNvPr>
              <p:cNvSpPr txBox="1"/>
              <p:nvPr/>
            </p:nvSpPr>
            <p:spPr>
              <a:xfrm rot="16200000">
                <a:off x="7002295" y="1475515"/>
                <a:ext cx="1019332" cy="4303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6+</a:t>
                </a:r>
              </a:p>
            </p:txBody>
          </p:sp>
        </p:grp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403F49EA-7953-4D26-6216-E2068CFDECF8}"/>
              </a:ext>
            </a:extLst>
          </p:cNvPr>
          <p:cNvGrpSpPr/>
          <p:nvPr/>
        </p:nvGrpSpPr>
        <p:grpSpPr>
          <a:xfrm>
            <a:off x="8448128" y="2277267"/>
            <a:ext cx="1800154" cy="1711797"/>
            <a:chOff x="6647392" y="2853388"/>
            <a:chExt cx="1860484" cy="1769166"/>
          </a:xfrm>
        </p:grpSpPr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B69FDA4A-FABF-9A56-74E3-997480EF10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7282" b="7746"/>
            <a:stretch/>
          </p:blipFill>
          <p:spPr>
            <a:xfrm>
              <a:off x="6647392" y="2853388"/>
              <a:ext cx="1860484" cy="1769166"/>
            </a:xfrm>
            <a:prstGeom prst="rect">
              <a:avLst/>
            </a:prstGeom>
          </p:spPr>
        </p:pic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751AD0B3-CD33-F714-4250-3305D4E57576}"/>
                </a:ext>
              </a:extLst>
            </p:cNvPr>
            <p:cNvSpPr/>
            <p:nvPr/>
          </p:nvSpPr>
          <p:spPr>
            <a:xfrm flipH="1" flipV="1">
              <a:off x="6924104" y="2960487"/>
              <a:ext cx="175634" cy="1282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0D449B22-79D5-6695-4637-AFF6E7631A36}"/>
                </a:ext>
              </a:extLst>
            </p:cNvPr>
            <p:cNvSpPr/>
            <p:nvPr/>
          </p:nvSpPr>
          <p:spPr>
            <a:xfrm flipH="1" flipV="1">
              <a:off x="8290449" y="2960486"/>
              <a:ext cx="175634" cy="1282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7" name="TextBox 96">
            <a:extLst>
              <a:ext uri="{FF2B5EF4-FFF2-40B4-BE49-F238E27FC236}">
                <a16:creationId xmlns:a16="http://schemas.microsoft.com/office/drawing/2014/main" id="{9B4C904A-507D-16F7-27EA-F73B9B0CC62A}"/>
              </a:ext>
            </a:extLst>
          </p:cNvPr>
          <p:cNvSpPr txBox="1"/>
          <p:nvPr/>
        </p:nvSpPr>
        <p:spPr>
          <a:xfrm>
            <a:off x="9571020" y="2254443"/>
            <a:ext cx="7152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.5%</a:t>
            </a:r>
          </a:p>
        </p:txBody>
      </p:sp>
      <p:grpSp>
        <p:nvGrpSpPr>
          <p:cNvPr id="98" name="Group 97">
            <a:extLst>
              <a:ext uri="{FF2B5EF4-FFF2-40B4-BE49-F238E27FC236}">
                <a16:creationId xmlns:a16="http://schemas.microsoft.com/office/drawing/2014/main" id="{7411F8FE-FECB-EAE4-A4FB-4C31AE808AA7}"/>
              </a:ext>
            </a:extLst>
          </p:cNvPr>
          <p:cNvGrpSpPr/>
          <p:nvPr/>
        </p:nvGrpSpPr>
        <p:grpSpPr>
          <a:xfrm>
            <a:off x="8715866" y="3991563"/>
            <a:ext cx="1529595" cy="383213"/>
            <a:chOff x="2137881" y="9437502"/>
            <a:chExt cx="1944526" cy="487167"/>
          </a:xfrm>
        </p:grpSpPr>
        <p:sp>
          <p:nvSpPr>
            <p:cNvPr id="99" name="Up Arrow 98">
              <a:extLst>
                <a:ext uri="{FF2B5EF4-FFF2-40B4-BE49-F238E27FC236}">
                  <a16:creationId xmlns:a16="http://schemas.microsoft.com/office/drawing/2014/main" id="{EA4D6C99-2A61-0425-7B78-794D618DFB46}"/>
                </a:ext>
              </a:extLst>
            </p:cNvPr>
            <p:cNvSpPr/>
            <p:nvPr/>
          </p:nvSpPr>
          <p:spPr>
            <a:xfrm rot="5400000">
              <a:off x="3044298" y="8531085"/>
              <a:ext cx="131692" cy="1944526"/>
            </a:xfrm>
            <a:prstGeom prst="upArrow">
              <a:avLst>
                <a:gd name="adj1" fmla="val 34646"/>
                <a:gd name="adj2" fmla="val 86466"/>
              </a:avLst>
            </a:prstGeom>
            <a:solidFill>
              <a:schemeClr val="tx1"/>
            </a:solidFill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5B58EB1F-BDD4-3CC8-458B-A8DAB3E1C1CA}"/>
                </a:ext>
              </a:extLst>
            </p:cNvPr>
            <p:cNvSpPr txBox="1"/>
            <p:nvPr/>
          </p:nvSpPr>
          <p:spPr>
            <a:xfrm>
              <a:off x="2612252" y="9494276"/>
              <a:ext cx="1149754" cy="43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63+</a:t>
              </a:r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B05F64AF-F008-8034-41E2-A9E9228BB523}"/>
              </a:ext>
            </a:extLst>
          </p:cNvPr>
          <p:cNvGrpSpPr/>
          <p:nvPr/>
        </p:nvGrpSpPr>
        <p:grpSpPr>
          <a:xfrm>
            <a:off x="10182214" y="2277267"/>
            <a:ext cx="2129482" cy="2097510"/>
            <a:chOff x="9975967" y="3344519"/>
            <a:chExt cx="2707143" cy="2666498"/>
          </a:xfrm>
        </p:grpSpPr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DB766525-4360-C621-4751-7CEE01C429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/>
            <a:srcRect l="7802" b="7746"/>
            <a:stretch/>
          </p:blipFill>
          <p:spPr>
            <a:xfrm>
              <a:off x="10450681" y="3344519"/>
              <a:ext cx="2232429" cy="2176152"/>
            </a:xfrm>
            <a:prstGeom prst="rect">
              <a:avLst/>
            </a:prstGeom>
          </p:spPr>
        </p:pic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81DC48D6-439B-7F3E-029E-A21C4888D264}"/>
                </a:ext>
              </a:extLst>
            </p:cNvPr>
            <p:cNvGrpSpPr/>
            <p:nvPr/>
          </p:nvGrpSpPr>
          <p:grpSpPr>
            <a:xfrm>
              <a:off x="10738584" y="5523850"/>
              <a:ext cx="1944526" cy="487167"/>
              <a:chOff x="2137881" y="9437502"/>
              <a:chExt cx="1944526" cy="487167"/>
            </a:xfrm>
          </p:grpSpPr>
          <p:sp>
            <p:nvSpPr>
              <p:cNvPr id="107" name="Up Arrow 106">
                <a:extLst>
                  <a:ext uri="{FF2B5EF4-FFF2-40B4-BE49-F238E27FC236}">
                    <a16:creationId xmlns:a16="http://schemas.microsoft.com/office/drawing/2014/main" id="{7C1CAC39-CD75-4798-7BEB-CFE18C458D05}"/>
                  </a:ext>
                </a:extLst>
              </p:cNvPr>
              <p:cNvSpPr/>
              <p:nvPr/>
            </p:nvSpPr>
            <p:spPr>
              <a:xfrm rot="5400000">
                <a:off x="3044298" y="8531085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78817D09-6CFA-F426-5686-7E6A377B27AD}"/>
                  </a:ext>
                </a:extLst>
              </p:cNvPr>
              <p:cNvSpPr txBox="1"/>
              <p:nvPr/>
            </p:nvSpPr>
            <p:spPr>
              <a:xfrm>
                <a:off x="2612252" y="9494276"/>
                <a:ext cx="1149754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73+</a:t>
                </a:r>
              </a:p>
            </p:txBody>
          </p:sp>
        </p:grp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D8B32A4C-70C1-5B25-824E-7A7DFEEC49F5}"/>
                </a:ext>
              </a:extLst>
            </p:cNvPr>
            <p:cNvGrpSpPr/>
            <p:nvPr/>
          </p:nvGrpSpPr>
          <p:grpSpPr>
            <a:xfrm>
              <a:off x="9975967" y="3347698"/>
              <a:ext cx="474714" cy="1944526"/>
              <a:chOff x="7296764" y="718449"/>
              <a:chExt cx="474714" cy="1944526"/>
            </a:xfrm>
          </p:grpSpPr>
          <p:sp>
            <p:nvSpPr>
              <p:cNvPr id="105" name="Up Arrow 104">
                <a:extLst>
                  <a:ext uri="{FF2B5EF4-FFF2-40B4-BE49-F238E27FC236}">
                    <a16:creationId xmlns:a16="http://schemas.microsoft.com/office/drawing/2014/main" id="{E406907A-9B68-1F1D-47F0-7543AAD452AF}"/>
                  </a:ext>
                </a:extLst>
              </p:cNvPr>
              <p:cNvSpPr/>
              <p:nvPr/>
            </p:nvSpPr>
            <p:spPr>
              <a:xfrm>
                <a:off x="7639786" y="718449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45E99269-B2B6-DC7A-58E9-FAD96EE8DFD4}"/>
                  </a:ext>
                </a:extLst>
              </p:cNvPr>
              <p:cNvSpPr txBox="1"/>
              <p:nvPr/>
            </p:nvSpPr>
            <p:spPr>
              <a:xfrm rot="16200000">
                <a:off x="6937084" y="1475515"/>
                <a:ext cx="1149754" cy="4303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06+</a:t>
                </a:r>
              </a:p>
            </p:txBody>
          </p:sp>
        </p:grp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3BF7BCA7-35D2-047D-490E-572E0373F208}"/>
              </a:ext>
            </a:extLst>
          </p:cNvPr>
          <p:cNvGrpSpPr/>
          <p:nvPr/>
        </p:nvGrpSpPr>
        <p:grpSpPr>
          <a:xfrm>
            <a:off x="8448128" y="4415120"/>
            <a:ext cx="1874676" cy="1723589"/>
            <a:chOff x="7771479" y="6062304"/>
            <a:chExt cx="2383216" cy="2191144"/>
          </a:xfrm>
        </p:grpSpPr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656B279D-E5EC-E036-11EC-E4A699A9B4AD}"/>
                </a:ext>
              </a:extLst>
            </p:cNvPr>
            <p:cNvGrpSpPr/>
            <p:nvPr/>
          </p:nvGrpSpPr>
          <p:grpSpPr>
            <a:xfrm>
              <a:off x="7771479" y="6077295"/>
              <a:ext cx="2288478" cy="2176153"/>
              <a:chOff x="6647392" y="5691717"/>
              <a:chExt cx="1860484" cy="1769166"/>
            </a:xfrm>
          </p:grpSpPr>
          <p:pic>
            <p:nvPicPr>
              <p:cNvPr id="112" name="Picture 111">
                <a:extLst>
                  <a:ext uri="{FF2B5EF4-FFF2-40B4-BE49-F238E27FC236}">
                    <a16:creationId xmlns:a16="http://schemas.microsoft.com/office/drawing/2014/main" id="{C3A56620-D75C-AA3E-E6CA-212196010D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7282" b="7746"/>
              <a:stretch/>
            </p:blipFill>
            <p:spPr>
              <a:xfrm>
                <a:off x="6647392" y="5691717"/>
                <a:ext cx="1860484" cy="1769166"/>
              </a:xfrm>
              <a:prstGeom prst="rect">
                <a:avLst/>
              </a:prstGeom>
            </p:spPr>
          </p:pic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5BF4441E-B1C7-D7E7-DDF5-7A41E3DEC385}"/>
                  </a:ext>
                </a:extLst>
              </p:cNvPr>
              <p:cNvSpPr/>
              <p:nvPr/>
            </p:nvSpPr>
            <p:spPr>
              <a:xfrm flipH="1" flipV="1">
                <a:off x="6924104" y="5772189"/>
                <a:ext cx="175634" cy="1282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565F7E3D-E22F-2BB5-7AF9-7369813A3020}"/>
                  </a:ext>
                </a:extLst>
              </p:cNvPr>
              <p:cNvSpPr/>
              <p:nvPr/>
            </p:nvSpPr>
            <p:spPr>
              <a:xfrm flipH="1" flipV="1">
                <a:off x="8290449" y="5772189"/>
                <a:ext cx="175634" cy="1282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F56B201A-6FF3-97AF-03F3-CF4072788914}"/>
                </a:ext>
              </a:extLst>
            </p:cNvPr>
            <p:cNvSpPr txBox="1"/>
            <p:nvPr/>
          </p:nvSpPr>
          <p:spPr>
            <a:xfrm>
              <a:off x="9245408" y="6062304"/>
              <a:ext cx="909287" cy="43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8.5%</a:t>
              </a:r>
            </a:p>
          </p:txBody>
        </p:sp>
      </p:grp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72CFB629-846F-5D51-0970-48A980E00E7F}"/>
              </a:ext>
            </a:extLst>
          </p:cNvPr>
          <p:cNvGrpSpPr/>
          <p:nvPr/>
        </p:nvGrpSpPr>
        <p:grpSpPr>
          <a:xfrm>
            <a:off x="8715866" y="6142469"/>
            <a:ext cx="1529595" cy="383213"/>
            <a:chOff x="2137881" y="9437502"/>
            <a:chExt cx="1944526" cy="487167"/>
          </a:xfrm>
        </p:grpSpPr>
        <p:sp>
          <p:nvSpPr>
            <p:cNvPr id="116" name="Up Arrow 115">
              <a:extLst>
                <a:ext uri="{FF2B5EF4-FFF2-40B4-BE49-F238E27FC236}">
                  <a16:creationId xmlns:a16="http://schemas.microsoft.com/office/drawing/2014/main" id="{0A4BE079-1DAA-D51D-EDA1-B37D757B0038}"/>
                </a:ext>
              </a:extLst>
            </p:cNvPr>
            <p:cNvSpPr/>
            <p:nvPr/>
          </p:nvSpPr>
          <p:spPr>
            <a:xfrm rot="5400000">
              <a:off x="3044298" y="8531085"/>
              <a:ext cx="131692" cy="1944526"/>
            </a:xfrm>
            <a:prstGeom prst="upArrow">
              <a:avLst>
                <a:gd name="adj1" fmla="val 34646"/>
                <a:gd name="adj2" fmla="val 86466"/>
              </a:avLst>
            </a:prstGeom>
            <a:solidFill>
              <a:schemeClr val="tx1"/>
            </a:solidFill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A5738E98-0BAB-E78F-A751-DA622B92AC7C}"/>
                </a:ext>
              </a:extLst>
            </p:cNvPr>
            <p:cNvSpPr txBox="1"/>
            <p:nvPr/>
          </p:nvSpPr>
          <p:spPr>
            <a:xfrm>
              <a:off x="2541719" y="9494276"/>
              <a:ext cx="1312782" cy="43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II+</a:t>
              </a:r>
            </a:p>
          </p:txBody>
        </p: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9D95F2D0-9E90-B925-E920-C722DDF800DF}"/>
              </a:ext>
            </a:extLst>
          </p:cNvPr>
          <p:cNvGrpSpPr/>
          <p:nvPr/>
        </p:nvGrpSpPr>
        <p:grpSpPr>
          <a:xfrm>
            <a:off x="10182214" y="4430673"/>
            <a:ext cx="2129482" cy="2095009"/>
            <a:chOff x="9975967" y="6082077"/>
            <a:chExt cx="2707143" cy="2663319"/>
          </a:xfrm>
        </p:grpSpPr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id="{C14596CB-11C9-3A6A-A05D-B6E71A01B1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/>
            <a:srcRect l="7802" b="7746"/>
            <a:stretch/>
          </p:blipFill>
          <p:spPr>
            <a:xfrm>
              <a:off x="10450681" y="6084789"/>
              <a:ext cx="2232429" cy="2176152"/>
            </a:xfrm>
            <a:prstGeom prst="rect">
              <a:avLst/>
            </a:prstGeom>
          </p:spPr>
        </p:pic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40C63A0C-CFDC-5E46-162D-9985D84B4735}"/>
                </a:ext>
              </a:extLst>
            </p:cNvPr>
            <p:cNvGrpSpPr/>
            <p:nvPr/>
          </p:nvGrpSpPr>
          <p:grpSpPr>
            <a:xfrm>
              <a:off x="10738584" y="8258229"/>
              <a:ext cx="1944526" cy="487167"/>
              <a:chOff x="2137881" y="9437502"/>
              <a:chExt cx="1944526" cy="487167"/>
            </a:xfrm>
          </p:grpSpPr>
          <p:sp>
            <p:nvSpPr>
              <p:cNvPr id="124" name="Up Arrow 123">
                <a:extLst>
                  <a:ext uri="{FF2B5EF4-FFF2-40B4-BE49-F238E27FC236}">
                    <a16:creationId xmlns:a16="http://schemas.microsoft.com/office/drawing/2014/main" id="{692832AD-0D47-9915-2451-3026ACF7D2F2}"/>
                  </a:ext>
                </a:extLst>
              </p:cNvPr>
              <p:cNvSpPr/>
              <p:nvPr/>
            </p:nvSpPr>
            <p:spPr>
              <a:xfrm rot="5400000">
                <a:off x="3044298" y="8531085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089AEE79-AFA7-F630-7532-36F57C4E0241}"/>
                  </a:ext>
                </a:extLst>
              </p:cNvPr>
              <p:cNvSpPr txBox="1"/>
              <p:nvPr/>
            </p:nvSpPr>
            <p:spPr>
              <a:xfrm>
                <a:off x="2669960" y="9494276"/>
                <a:ext cx="1019332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0+</a:t>
                </a:r>
              </a:p>
            </p:txBody>
          </p: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06280529-C224-46DA-D983-7EE820A016CD}"/>
                </a:ext>
              </a:extLst>
            </p:cNvPr>
            <p:cNvGrpSpPr/>
            <p:nvPr/>
          </p:nvGrpSpPr>
          <p:grpSpPr>
            <a:xfrm>
              <a:off x="9975967" y="6082077"/>
              <a:ext cx="474714" cy="1944526"/>
              <a:chOff x="7296764" y="718449"/>
              <a:chExt cx="474714" cy="1944526"/>
            </a:xfrm>
          </p:grpSpPr>
          <p:sp>
            <p:nvSpPr>
              <p:cNvPr id="122" name="Up Arrow 121">
                <a:extLst>
                  <a:ext uri="{FF2B5EF4-FFF2-40B4-BE49-F238E27FC236}">
                    <a16:creationId xmlns:a16="http://schemas.microsoft.com/office/drawing/2014/main" id="{872349CE-D048-36CF-1121-50F685DB4AD1}"/>
                  </a:ext>
                </a:extLst>
              </p:cNvPr>
              <p:cNvSpPr/>
              <p:nvPr/>
            </p:nvSpPr>
            <p:spPr>
              <a:xfrm>
                <a:off x="7639786" y="718449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53938D63-C04A-C4F9-F8AD-5EAF84891B36}"/>
                  </a:ext>
                </a:extLst>
              </p:cNvPr>
              <p:cNvSpPr txBox="1"/>
              <p:nvPr/>
            </p:nvSpPr>
            <p:spPr>
              <a:xfrm rot="16200000">
                <a:off x="7002295" y="1475515"/>
                <a:ext cx="1019332" cy="4303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6+</a:t>
                </a:r>
              </a:p>
            </p:txBody>
          </p:sp>
        </p:grpSp>
      </p:grp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88F135A9-D803-F8EF-A8F3-C58BB8114FDC}"/>
              </a:ext>
            </a:extLst>
          </p:cNvPr>
          <p:cNvGrpSpPr/>
          <p:nvPr/>
        </p:nvGrpSpPr>
        <p:grpSpPr>
          <a:xfrm>
            <a:off x="8455720" y="6473704"/>
            <a:ext cx="1867084" cy="1736976"/>
            <a:chOff x="7781130" y="8664327"/>
            <a:chExt cx="2373565" cy="2208162"/>
          </a:xfrm>
        </p:grpSpPr>
        <p:grpSp>
          <p:nvGrpSpPr>
            <p:cNvPr id="127" name="Group 126">
              <a:extLst>
                <a:ext uri="{FF2B5EF4-FFF2-40B4-BE49-F238E27FC236}">
                  <a16:creationId xmlns:a16="http://schemas.microsoft.com/office/drawing/2014/main" id="{50E75268-3D83-18DD-568D-02ACDAFCC35F}"/>
                </a:ext>
              </a:extLst>
            </p:cNvPr>
            <p:cNvGrpSpPr/>
            <p:nvPr/>
          </p:nvGrpSpPr>
          <p:grpSpPr>
            <a:xfrm>
              <a:off x="7781130" y="8688374"/>
              <a:ext cx="2278824" cy="2184115"/>
              <a:chOff x="6655240" y="7814469"/>
              <a:chExt cx="1852636" cy="1775639"/>
            </a:xfrm>
          </p:grpSpPr>
          <p:pic>
            <p:nvPicPr>
              <p:cNvPr id="129" name="Picture 128">
                <a:extLst>
                  <a:ext uri="{FF2B5EF4-FFF2-40B4-BE49-F238E27FC236}">
                    <a16:creationId xmlns:a16="http://schemas.microsoft.com/office/drawing/2014/main" id="{19FF117B-BF4F-4810-EE49-A12762C17B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l="7673" b="7408"/>
              <a:stretch/>
            </p:blipFill>
            <p:spPr>
              <a:xfrm>
                <a:off x="6655240" y="7814469"/>
                <a:ext cx="1852636" cy="1775639"/>
              </a:xfrm>
              <a:prstGeom prst="rect">
                <a:avLst/>
              </a:prstGeom>
            </p:spPr>
          </p:pic>
          <p:sp>
            <p:nvSpPr>
              <p:cNvPr id="130" name="Rectangle 129">
                <a:extLst>
                  <a:ext uri="{FF2B5EF4-FFF2-40B4-BE49-F238E27FC236}">
                    <a16:creationId xmlns:a16="http://schemas.microsoft.com/office/drawing/2014/main" id="{FCEE4A42-FC64-B7C7-A64D-59AC54611DFE}"/>
                  </a:ext>
                </a:extLst>
              </p:cNvPr>
              <p:cNvSpPr/>
              <p:nvPr/>
            </p:nvSpPr>
            <p:spPr>
              <a:xfrm flipH="1" flipV="1">
                <a:off x="6924104" y="7906892"/>
                <a:ext cx="175634" cy="1282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59A36DEB-2269-8ED7-0F99-B152C5F28758}"/>
                  </a:ext>
                </a:extLst>
              </p:cNvPr>
              <p:cNvSpPr/>
              <p:nvPr/>
            </p:nvSpPr>
            <p:spPr>
              <a:xfrm flipH="1" flipV="1">
                <a:off x="8290449" y="7906891"/>
                <a:ext cx="175634" cy="1282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53657197-256B-2FC4-023B-5B8AB4F014C4}"/>
                </a:ext>
              </a:extLst>
            </p:cNvPr>
            <p:cNvSpPr txBox="1"/>
            <p:nvPr/>
          </p:nvSpPr>
          <p:spPr>
            <a:xfrm>
              <a:off x="9245408" y="8664327"/>
              <a:ext cx="909287" cy="43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5.1%</a:t>
              </a:r>
            </a:p>
          </p:txBody>
        </p:sp>
      </p:grp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8C5840C6-A443-7F46-C85B-BB72D9E98C2B}"/>
              </a:ext>
            </a:extLst>
          </p:cNvPr>
          <p:cNvGrpSpPr/>
          <p:nvPr/>
        </p:nvGrpSpPr>
        <p:grpSpPr>
          <a:xfrm>
            <a:off x="8715866" y="8210679"/>
            <a:ext cx="1529595" cy="383213"/>
            <a:chOff x="2137881" y="9437502"/>
            <a:chExt cx="1944526" cy="487167"/>
          </a:xfrm>
        </p:grpSpPr>
        <p:sp>
          <p:nvSpPr>
            <p:cNvPr id="133" name="Up Arrow 132">
              <a:extLst>
                <a:ext uri="{FF2B5EF4-FFF2-40B4-BE49-F238E27FC236}">
                  <a16:creationId xmlns:a16="http://schemas.microsoft.com/office/drawing/2014/main" id="{ED943ECD-E60A-CD85-DDC8-99192769D967}"/>
                </a:ext>
              </a:extLst>
            </p:cNvPr>
            <p:cNvSpPr/>
            <p:nvPr/>
          </p:nvSpPr>
          <p:spPr>
            <a:xfrm rot="5400000">
              <a:off x="3044298" y="8531085"/>
              <a:ext cx="131692" cy="1944526"/>
            </a:xfrm>
            <a:prstGeom prst="upArrow">
              <a:avLst>
                <a:gd name="adj1" fmla="val 34646"/>
                <a:gd name="adj2" fmla="val 86466"/>
              </a:avLst>
            </a:prstGeom>
            <a:solidFill>
              <a:schemeClr val="tx1"/>
            </a:solidFill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6325245-A60A-07D6-0256-9CE215B1A918}"/>
                </a:ext>
              </a:extLst>
            </p:cNvPr>
            <p:cNvSpPr txBox="1"/>
            <p:nvPr/>
          </p:nvSpPr>
          <p:spPr>
            <a:xfrm>
              <a:off x="2612252" y="9494276"/>
              <a:ext cx="1149754" cy="43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63+</a:t>
              </a:r>
            </a:p>
          </p:txBody>
        </p:sp>
      </p:grp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196B5AE6-B7F3-B35A-CDB5-CB329A656761}"/>
              </a:ext>
            </a:extLst>
          </p:cNvPr>
          <p:cNvGrpSpPr/>
          <p:nvPr/>
        </p:nvGrpSpPr>
        <p:grpSpPr>
          <a:xfrm>
            <a:off x="8074709" y="4430673"/>
            <a:ext cx="373418" cy="3597804"/>
            <a:chOff x="7296763" y="718449"/>
            <a:chExt cx="474715" cy="1944526"/>
          </a:xfrm>
        </p:grpSpPr>
        <p:sp>
          <p:nvSpPr>
            <p:cNvPr id="136" name="Up Arrow 135">
              <a:extLst>
                <a:ext uri="{FF2B5EF4-FFF2-40B4-BE49-F238E27FC236}">
                  <a16:creationId xmlns:a16="http://schemas.microsoft.com/office/drawing/2014/main" id="{FAEDFFCF-597D-FCE3-D5A9-DCB1784E6B95}"/>
                </a:ext>
              </a:extLst>
            </p:cNvPr>
            <p:cNvSpPr/>
            <p:nvPr/>
          </p:nvSpPr>
          <p:spPr>
            <a:xfrm>
              <a:off x="7639786" y="718449"/>
              <a:ext cx="131692" cy="1944526"/>
            </a:xfrm>
            <a:prstGeom prst="upArrow">
              <a:avLst>
                <a:gd name="adj1" fmla="val 34646"/>
                <a:gd name="adj2" fmla="val 86466"/>
              </a:avLst>
            </a:prstGeom>
            <a:solidFill>
              <a:schemeClr val="tx1"/>
            </a:solidFill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B902443E-C7B8-9529-B266-D7BB33397983}"/>
                </a:ext>
              </a:extLst>
            </p:cNvPr>
            <p:cNvSpPr txBox="1"/>
            <p:nvPr/>
          </p:nvSpPr>
          <p:spPr>
            <a:xfrm rot="16200000">
              <a:off x="7302208" y="1475515"/>
              <a:ext cx="419504" cy="430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</p:grp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8C1B51FB-86BF-75DD-81B8-66D1F5C0F916}"/>
              </a:ext>
            </a:extLst>
          </p:cNvPr>
          <p:cNvGrpSpPr/>
          <p:nvPr/>
        </p:nvGrpSpPr>
        <p:grpSpPr>
          <a:xfrm>
            <a:off x="10182214" y="6492619"/>
            <a:ext cx="2129482" cy="2101273"/>
            <a:chOff x="9975967" y="8703363"/>
            <a:chExt cx="2707143" cy="2671282"/>
          </a:xfrm>
        </p:grpSpPr>
        <p:pic>
          <p:nvPicPr>
            <p:cNvPr id="139" name="Picture 138">
              <a:extLst>
                <a:ext uri="{FF2B5EF4-FFF2-40B4-BE49-F238E27FC236}">
                  <a16:creationId xmlns:a16="http://schemas.microsoft.com/office/drawing/2014/main" id="{64C1097C-BCE7-161B-F35B-97CD0F78A5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/>
            <a:srcRect l="7802" b="7408"/>
            <a:stretch/>
          </p:blipFill>
          <p:spPr>
            <a:xfrm>
              <a:off x="10450681" y="8703363"/>
              <a:ext cx="2232429" cy="2184115"/>
            </a:xfrm>
            <a:prstGeom prst="rect">
              <a:avLst/>
            </a:prstGeom>
          </p:spPr>
        </p:pic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894B3446-5D68-CE36-6397-51B339FD4790}"/>
                </a:ext>
              </a:extLst>
            </p:cNvPr>
            <p:cNvGrpSpPr/>
            <p:nvPr/>
          </p:nvGrpSpPr>
          <p:grpSpPr>
            <a:xfrm>
              <a:off x="10738584" y="10887478"/>
              <a:ext cx="1944526" cy="487167"/>
              <a:chOff x="2137881" y="9437502"/>
              <a:chExt cx="1944526" cy="487167"/>
            </a:xfrm>
          </p:grpSpPr>
          <p:sp>
            <p:nvSpPr>
              <p:cNvPr id="144" name="Up Arrow 143">
                <a:extLst>
                  <a:ext uri="{FF2B5EF4-FFF2-40B4-BE49-F238E27FC236}">
                    <a16:creationId xmlns:a16="http://schemas.microsoft.com/office/drawing/2014/main" id="{1691B2E4-3156-C227-34E0-50B2E400A05B}"/>
                  </a:ext>
                </a:extLst>
              </p:cNvPr>
              <p:cNvSpPr/>
              <p:nvPr/>
            </p:nvSpPr>
            <p:spPr>
              <a:xfrm rot="5400000">
                <a:off x="3044298" y="8531085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B3792F19-4CF9-E267-678E-9E60FE83E548}"/>
                  </a:ext>
                </a:extLst>
              </p:cNvPr>
              <p:cNvSpPr txBox="1"/>
              <p:nvPr/>
            </p:nvSpPr>
            <p:spPr>
              <a:xfrm>
                <a:off x="2612252" y="9494276"/>
                <a:ext cx="1149754" cy="430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73+</a:t>
                </a:r>
              </a:p>
            </p:txBody>
          </p:sp>
        </p:grpSp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FE59DB1C-798F-1FED-0692-07E7E22DEF2E}"/>
                </a:ext>
              </a:extLst>
            </p:cNvPr>
            <p:cNvGrpSpPr/>
            <p:nvPr/>
          </p:nvGrpSpPr>
          <p:grpSpPr>
            <a:xfrm>
              <a:off x="9975967" y="8711326"/>
              <a:ext cx="474714" cy="1944526"/>
              <a:chOff x="7296764" y="718449"/>
              <a:chExt cx="474714" cy="1944526"/>
            </a:xfrm>
          </p:grpSpPr>
          <p:sp>
            <p:nvSpPr>
              <p:cNvPr id="142" name="Up Arrow 141">
                <a:extLst>
                  <a:ext uri="{FF2B5EF4-FFF2-40B4-BE49-F238E27FC236}">
                    <a16:creationId xmlns:a16="http://schemas.microsoft.com/office/drawing/2014/main" id="{23B4E45E-F248-170F-EF5A-6A5910214842}"/>
                  </a:ext>
                </a:extLst>
              </p:cNvPr>
              <p:cNvSpPr/>
              <p:nvPr/>
            </p:nvSpPr>
            <p:spPr>
              <a:xfrm>
                <a:off x="7639786" y="718449"/>
                <a:ext cx="131692" cy="1944526"/>
              </a:xfrm>
              <a:prstGeom prst="upArrow">
                <a:avLst>
                  <a:gd name="adj1" fmla="val 34646"/>
                  <a:gd name="adj2" fmla="val 86466"/>
                </a:avLst>
              </a:prstGeom>
              <a:solidFill>
                <a:schemeClr val="tx1"/>
              </a:solidFill>
              <a:effec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4288561A-7199-3E4C-B6FA-65D622C53FD5}"/>
                  </a:ext>
                </a:extLst>
              </p:cNvPr>
              <p:cNvSpPr txBox="1"/>
              <p:nvPr/>
            </p:nvSpPr>
            <p:spPr>
              <a:xfrm rot="16200000">
                <a:off x="6937084" y="1475515"/>
                <a:ext cx="1149754" cy="4303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06+</a:t>
                </a:r>
              </a:p>
            </p:txBody>
          </p:sp>
        </p:grp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6C3D7741-A50D-5EAF-25D7-6A8FE2F874D8}"/>
              </a:ext>
            </a:extLst>
          </p:cNvPr>
          <p:cNvGrpSpPr/>
          <p:nvPr/>
        </p:nvGrpSpPr>
        <p:grpSpPr>
          <a:xfrm>
            <a:off x="8074709" y="230832"/>
            <a:ext cx="373418" cy="3597804"/>
            <a:chOff x="7296763" y="718449"/>
            <a:chExt cx="474715" cy="1944526"/>
          </a:xfrm>
        </p:grpSpPr>
        <p:sp>
          <p:nvSpPr>
            <p:cNvPr id="147" name="Up Arrow 146">
              <a:extLst>
                <a:ext uri="{FF2B5EF4-FFF2-40B4-BE49-F238E27FC236}">
                  <a16:creationId xmlns:a16="http://schemas.microsoft.com/office/drawing/2014/main" id="{902116B6-B80E-7C6C-2074-0971BCE99732}"/>
                </a:ext>
              </a:extLst>
            </p:cNvPr>
            <p:cNvSpPr/>
            <p:nvPr/>
          </p:nvSpPr>
          <p:spPr>
            <a:xfrm>
              <a:off x="7639786" y="718449"/>
              <a:ext cx="131692" cy="1944526"/>
            </a:xfrm>
            <a:prstGeom prst="upArrow">
              <a:avLst>
                <a:gd name="adj1" fmla="val 34646"/>
                <a:gd name="adj2" fmla="val 86466"/>
              </a:avLst>
            </a:prstGeom>
            <a:solidFill>
              <a:schemeClr val="tx1"/>
            </a:solidFill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9322F833-AFD3-F661-A946-6CD510CA4DE4}"/>
                </a:ext>
              </a:extLst>
            </p:cNvPr>
            <p:cNvSpPr txBox="1"/>
            <p:nvPr/>
          </p:nvSpPr>
          <p:spPr>
            <a:xfrm rot="16200000">
              <a:off x="7302208" y="1475515"/>
              <a:ext cx="419504" cy="430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</p:grpSp>
      <p:sp>
        <p:nvSpPr>
          <p:cNvPr id="149" name="TextBox 148">
            <a:extLst>
              <a:ext uri="{FF2B5EF4-FFF2-40B4-BE49-F238E27FC236}">
                <a16:creationId xmlns:a16="http://schemas.microsoft.com/office/drawing/2014/main" id="{24E62A13-4869-4677-5FE4-0AC0DFF21EC9}"/>
              </a:ext>
            </a:extLst>
          </p:cNvPr>
          <p:cNvSpPr txBox="1"/>
          <p:nvPr/>
        </p:nvSpPr>
        <p:spPr>
          <a:xfrm>
            <a:off x="7902297" y="794779"/>
            <a:ext cx="5549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B8A6C26D-0554-F38B-9A27-7570167B7ECE}"/>
              </a:ext>
            </a:extLst>
          </p:cNvPr>
          <p:cNvSpPr txBox="1"/>
          <p:nvPr/>
        </p:nvSpPr>
        <p:spPr>
          <a:xfrm>
            <a:off x="7902297" y="2860810"/>
            <a:ext cx="5549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2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671269B-2C0A-AB67-13D3-B782DEC727C1}"/>
              </a:ext>
            </a:extLst>
          </p:cNvPr>
          <p:cNvSpPr txBox="1"/>
          <p:nvPr/>
        </p:nvSpPr>
        <p:spPr>
          <a:xfrm>
            <a:off x="7902297" y="4940607"/>
            <a:ext cx="5549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9A6B046A-4AFB-39FA-FCB6-FB6EA893A113}"/>
              </a:ext>
            </a:extLst>
          </p:cNvPr>
          <p:cNvSpPr txBox="1"/>
          <p:nvPr/>
        </p:nvSpPr>
        <p:spPr>
          <a:xfrm>
            <a:off x="7902297" y="7114905"/>
            <a:ext cx="5549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2</a:t>
            </a:r>
          </a:p>
        </p:txBody>
      </p:sp>
      <p:sp>
        <p:nvSpPr>
          <p:cNvPr id="153" name="Up Arrow 152">
            <a:extLst>
              <a:ext uri="{FF2B5EF4-FFF2-40B4-BE49-F238E27FC236}">
                <a16:creationId xmlns:a16="http://schemas.microsoft.com/office/drawing/2014/main" id="{1A0CBAA8-19D1-673F-8BEC-92300A8152BE}"/>
              </a:ext>
            </a:extLst>
          </p:cNvPr>
          <p:cNvSpPr/>
          <p:nvPr/>
        </p:nvSpPr>
        <p:spPr>
          <a:xfrm rot="2931892">
            <a:off x="7433961" y="2184866"/>
            <a:ext cx="103591" cy="1373828"/>
          </a:xfrm>
          <a:prstGeom prst="upArrow">
            <a:avLst>
              <a:gd name="adj1" fmla="val 34646"/>
              <a:gd name="adj2" fmla="val 86466"/>
            </a:avLst>
          </a:prstGeom>
          <a:solidFill>
            <a:schemeClr val="tx1"/>
          </a:solidFill>
          <a:effectLst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Up Arrow 153">
            <a:extLst>
              <a:ext uri="{FF2B5EF4-FFF2-40B4-BE49-F238E27FC236}">
                <a16:creationId xmlns:a16="http://schemas.microsoft.com/office/drawing/2014/main" id="{78A0BA1F-6E7B-0527-7100-2E70573F42FC}"/>
              </a:ext>
            </a:extLst>
          </p:cNvPr>
          <p:cNvSpPr/>
          <p:nvPr/>
        </p:nvSpPr>
        <p:spPr>
          <a:xfrm rot="7216686">
            <a:off x="7501605" y="4855105"/>
            <a:ext cx="103591" cy="1373244"/>
          </a:xfrm>
          <a:prstGeom prst="upArrow">
            <a:avLst>
              <a:gd name="adj1" fmla="val 34646"/>
              <a:gd name="adj2" fmla="val 86466"/>
            </a:avLst>
          </a:prstGeom>
          <a:solidFill>
            <a:schemeClr val="tx1"/>
          </a:solidFill>
          <a:effectLst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CD052AF6-4FEA-B801-8223-4A7D567EF8B2}"/>
              </a:ext>
            </a:extLst>
          </p:cNvPr>
          <p:cNvSpPr txBox="1"/>
          <p:nvPr/>
        </p:nvSpPr>
        <p:spPr>
          <a:xfrm rot="10800000" flipH="1" flipV="1">
            <a:off x="22525" y="8690317"/>
            <a:ext cx="897915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400328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3">
      <a:dk1>
        <a:srgbClr val="000000"/>
      </a:dk1>
      <a:lt1>
        <a:srgbClr val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600" dirty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DenayLuis_Paper layout V1" id="{E285C894-8600-BE43-9C63-6DC2C64A29EE}" vid="{C2BEA0BC-9915-6141-982A-C72D398425BF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10</TotalTime>
  <Words>208</Words>
  <Application>Microsoft Macintosh PowerPoint</Application>
  <PresentationFormat>Custom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ISAs of polarized macrophage supernatants: TNF-α and IL-1β (M1)</dc:title>
  <dc:creator>Microsoft Office User</dc:creator>
  <cp:lastModifiedBy>Carrie House</cp:lastModifiedBy>
  <cp:revision>79</cp:revision>
  <dcterms:created xsi:type="dcterms:W3CDTF">2022-01-18T04:14:07Z</dcterms:created>
  <dcterms:modified xsi:type="dcterms:W3CDTF">2024-08-20T23:34:01Z</dcterms:modified>
</cp:coreProperties>
</file>